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3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719" autoAdjust="0"/>
  </p:normalViewPr>
  <p:slideViewPr>
    <p:cSldViewPr>
      <p:cViewPr>
        <p:scale>
          <a:sx n="70" d="100"/>
          <a:sy n="70" d="100"/>
        </p:scale>
        <p:origin x="-1716" y="-29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D0C127A-65D9-4257-AB54-BFF2575DCB07}" type="datetimeFigureOut">
              <a:rPr lang="en-GB" smtClean="0"/>
              <a:pPr/>
              <a:t>02/09/201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5BD48EF-94A9-49AB-8904-D956D12BAD47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79899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ECA2C36-B6DE-4864-9339-FADEE753FB8F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2/09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2/09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2/09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2/09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2/09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2/09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2/09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2/09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2/09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2/09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2/09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BB7C45-EAAB-475C-BF0F-6EA14F973924}" type="datetimeFigureOut">
              <a:rPr lang="en-GB" smtClean="0"/>
              <a:pPr/>
              <a:t>02/09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/>
          <p:cNvGrpSpPr>
            <a:grpSpLocks noChangeAspect="1"/>
          </p:cNvGrpSpPr>
          <p:nvPr/>
        </p:nvGrpSpPr>
        <p:grpSpPr>
          <a:xfrm>
            <a:off x="764704" y="971600"/>
            <a:ext cx="5355458" cy="5976664"/>
            <a:chOff x="620688" y="179512"/>
            <a:chExt cx="3960224" cy="4482336"/>
          </a:xfrm>
        </p:grpSpPr>
        <p:pic>
          <p:nvPicPr>
            <p:cNvPr id="15" name="Picture 6" descr="C:\Documents and Settings\mobs4ah2\My Documents\PhD\Thesis\S LXRb Foll.jpg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2636912" y="1691680"/>
              <a:ext cx="1944000" cy="1458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pic>
          <p:nvPicPr>
            <p:cNvPr id="14" name="Picture 5" descr="C:\Documents and Settings\mobs4ah2\My Documents\PhD\Thesis\S LXRa Foll.jpg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620688" y="1691680"/>
              <a:ext cx="1944000" cy="1458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pic>
          <p:nvPicPr>
            <p:cNvPr id="3" name="Picture 3" descr="C:\Documents and Settings\mobs4ah2\My Documents\PhD\Thesis\COPD LXRa Foll.jpg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620688" y="3203848"/>
              <a:ext cx="1944000" cy="1458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pic>
          <p:nvPicPr>
            <p:cNvPr id="4" name="Picture 4" descr="C:\Documents and Settings\mobs4ah2\My Documents\PhD\Thesis\COPD LXRb Foll.jpg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2636912" y="3203848"/>
              <a:ext cx="1944000" cy="1458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pic>
          <p:nvPicPr>
            <p:cNvPr id="7" name="Picture 7" descr="C:\Documents and Settings\mobs4ah2\My Documents\PhD\Thesis\NS LXRa Foll.jpg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620688" y="179512"/>
              <a:ext cx="1944000" cy="1458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pic>
          <p:nvPicPr>
            <p:cNvPr id="8" name="Picture 10" descr="C:\Documents and Settings\mobs4ah2\My Documents\PhD\Thesis\NS LXRb Foll.jpg"/>
            <p:cNvPicPr>
              <a:picLocks noChangeAspect="1"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2636912" y="179512"/>
              <a:ext cx="1944000" cy="1458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sp>
          <p:nvSpPr>
            <p:cNvPr id="9" name="Text Box 52"/>
            <p:cNvSpPr txBox="1">
              <a:spLocks noChangeArrowheads="1"/>
            </p:cNvSpPr>
            <p:nvPr/>
          </p:nvSpPr>
          <p:spPr bwMode="auto">
            <a:xfrm>
              <a:off x="620688" y="206177"/>
              <a:ext cx="493713" cy="3333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1000"/>
                </a:spcAft>
                <a:buClrTx/>
                <a:buSzTx/>
                <a:buFontTx/>
                <a:buNone/>
                <a:tabLst/>
              </a:pPr>
              <a:r>
                <a:rPr kumimoji="0" lang="en-GB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Calibri" pitchFamily="34" charset="0"/>
                  <a:cs typeface="Arial" pitchFamily="34" charset="0"/>
                </a:rPr>
                <a:t>(A)</a:t>
              </a:r>
              <a:endPara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Text Box 56"/>
            <p:cNvSpPr txBox="1">
              <a:spLocks noChangeArrowheads="1"/>
            </p:cNvSpPr>
            <p:nvPr/>
          </p:nvSpPr>
          <p:spPr bwMode="auto">
            <a:xfrm>
              <a:off x="2636912" y="206177"/>
              <a:ext cx="485775" cy="3333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1000"/>
                </a:spcAft>
                <a:buClrTx/>
                <a:buSzTx/>
                <a:buFontTx/>
                <a:buNone/>
                <a:tabLst/>
              </a:pPr>
              <a:r>
                <a:rPr kumimoji="0" lang="en-GB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Calibri" pitchFamily="34" charset="0"/>
                  <a:cs typeface="Arial" pitchFamily="34" charset="0"/>
                </a:rPr>
                <a:t>(B)</a:t>
              </a:r>
              <a:endPara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Text Box 56"/>
            <p:cNvSpPr txBox="1">
              <a:spLocks noChangeArrowheads="1"/>
            </p:cNvSpPr>
            <p:nvPr/>
          </p:nvSpPr>
          <p:spPr bwMode="auto">
            <a:xfrm>
              <a:off x="620688" y="1691680"/>
              <a:ext cx="485775" cy="3333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1000"/>
                </a:spcAft>
                <a:buClrTx/>
                <a:buSzTx/>
                <a:buFontTx/>
                <a:buNone/>
                <a:tabLst/>
              </a:pPr>
              <a:r>
                <a:rPr kumimoji="0" lang="en-GB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Calibri" pitchFamily="34" charset="0"/>
                  <a:cs typeface="Arial" pitchFamily="34" charset="0"/>
                </a:rPr>
                <a:t>(C)</a:t>
              </a:r>
              <a:endPara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Text Box 56"/>
            <p:cNvSpPr txBox="1">
              <a:spLocks noChangeArrowheads="1"/>
            </p:cNvSpPr>
            <p:nvPr/>
          </p:nvSpPr>
          <p:spPr bwMode="auto">
            <a:xfrm>
              <a:off x="2636912" y="1691680"/>
              <a:ext cx="485775" cy="3333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1000"/>
                </a:spcAft>
                <a:buClrTx/>
                <a:buSzTx/>
                <a:buFontTx/>
                <a:buNone/>
                <a:tabLst/>
              </a:pPr>
              <a:r>
                <a:rPr kumimoji="0" lang="en-GB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Calibri" pitchFamily="34" charset="0"/>
                  <a:cs typeface="Arial" pitchFamily="34" charset="0"/>
                </a:rPr>
                <a:t>(D)</a:t>
              </a:r>
              <a:endPara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Text Box 56"/>
            <p:cNvSpPr txBox="1">
              <a:spLocks noChangeArrowheads="1"/>
            </p:cNvSpPr>
            <p:nvPr/>
          </p:nvSpPr>
          <p:spPr bwMode="auto">
            <a:xfrm>
              <a:off x="620688" y="3230513"/>
              <a:ext cx="485775" cy="3333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1000"/>
                </a:spcAft>
                <a:buClrTx/>
                <a:buSzTx/>
                <a:buFontTx/>
                <a:buNone/>
                <a:tabLst/>
              </a:pPr>
              <a:r>
                <a:rPr kumimoji="0" lang="en-GB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Calibri" pitchFamily="34" charset="0"/>
                  <a:cs typeface="Arial" pitchFamily="34" charset="0"/>
                </a:rPr>
                <a:t>(E)</a:t>
              </a:r>
              <a:endPara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Text Box 56"/>
            <p:cNvSpPr txBox="1">
              <a:spLocks noChangeArrowheads="1"/>
            </p:cNvSpPr>
            <p:nvPr/>
          </p:nvSpPr>
          <p:spPr bwMode="auto">
            <a:xfrm>
              <a:off x="2636912" y="3230513"/>
              <a:ext cx="485775" cy="3333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1000"/>
                </a:spcAft>
                <a:buClrTx/>
                <a:buSzTx/>
                <a:buFontTx/>
                <a:buNone/>
                <a:tabLst/>
              </a:pPr>
              <a:r>
                <a:rPr kumimoji="0" lang="en-GB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Calibri" pitchFamily="34" charset="0"/>
                  <a:cs typeface="Arial" pitchFamily="34" charset="0"/>
                </a:rPr>
                <a:t>(F)</a:t>
              </a:r>
              <a:endPara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9" name="Rectangle 3"/>
          <p:cNvSpPr>
            <a:spLocks noChangeAspect="1" noChangeArrowheads="1"/>
          </p:cNvSpPr>
          <p:nvPr/>
        </p:nvSpPr>
        <p:spPr bwMode="auto">
          <a:xfrm>
            <a:off x="9312" y="458252"/>
            <a:ext cx="62280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Additional File 3  </a:t>
            </a:r>
            <a:endParaRPr kumimoji="0" lang="en-GB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49" name="Rectangle 1"/>
          <p:cNvSpPr>
            <a:spLocks noChangeArrowheads="1"/>
          </p:cNvSpPr>
          <p:nvPr/>
        </p:nvSpPr>
        <p:spPr bwMode="auto">
          <a:xfrm>
            <a:off x="692696" y="7215971"/>
            <a:ext cx="5472608" cy="8309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Representative images of </a:t>
            </a:r>
            <a:r>
              <a:rPr kumimoji="0" lang="en-GB" sz="12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LXRα</a:t>
            </a:r>
            <a:r>
              <a:rPr kumimoji="0" lang="en-GB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 and </a:t>
            </a:r>
            <a:r>
              <a:rPr kumimoji="0" lang="en-GB" sz="12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LXRβ</a:t>
            </a:r>
            <a:r>
              <a:rPr kumimoji="0" lang="en-GB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 expression in lymphocytic aggregates.  </a:t>
            </a:r>
            <a:endParaRPr kumimoji="0" lang="en-GB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The distribution of LXRα (A, C, and E) and LXRβ (B, D, and F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) 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within lymphocytic aggregates present in lung sections of non-smoking controls (NS) (A-B), smoking controls (S) (C-D), and COPD patients (E-F).</a:t>
            </a:r>
            <a:endParaRPr kumimoji="0" lang="en-GB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2</TotalTime>
  <Words>85</Words>
  <Application>Microsoft Office PowerPoint</Application>
  <PresentationFormat>On-screen Show (4:3)</PresentationFormat>
  <Paragraphs>10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imon Lea</dc:creator>
  <cp:lastModifiedBy>Andrew Higham</cp:lastModifiedBy>
  <cp:revision>44</cp:revision>
  <dcterms:created xsi:type="dcterms:W3CDTF">2012-05-28T12:09:01Z</dcterms:created>
  <dcterms:modified xsi:type="dcterms:W3CDTF">2013-09-02T15:21:05Z</dcterms:modified>
</cp:coreProperties>
</file>